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71" r:id="rId2"/>
    <p:sldId id="275" r:id="rId3"/>
    <p:sldId id="272" r:id="rId4"/>
    <p:sldId id="276" r:id="rId5"/>
    <p:sldId id="273" r:id="rId6"/>
    <p:sldId id="274" r:id="rId7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  <a:srgbClr val="FF0000"/>
    <a:srgbClr val="006600"/>
    <a:srgbClr val="3399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1"/>
    <p:restoredTop sz="94660"/>
  </p:normalViewPr>
  <p:slideViewPr>
    <p:cSldViewPr snapToGrid="0">
      <p:cViewPr varScale="1">
        <p:scale>
          <a:sx n="86" d="100"/>
          <a:sy n="86" d="100"/>
        </p:scale>
        <p:origin x="2952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4CF089A-F9FE-4823-8A43-7BD66EB49CAC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8412CE-E1B1-4893-AE65-954872B15B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779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B1FB0-4F85-4F5C-ACEF-5DBE33461DB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66505-BB2C-40BD-A9E4-BC1351537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116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B1FB0-4F85-4F5C-ACEF-5DBE33461DB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66505-BB2C-40BD-A9E4-BC1351537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165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B1FB0-4F85-4F5C-ACEF-5DBE33461DB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66505-BB2C-40BD-A9E4-BC1351537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2878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B1FB0-4F85-4F5C-ACEF-5DBE33461DB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66505-BB2C-40BD-A9E4-BC1351537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441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B1FB0-4F85-4F5C-ACEF-5DBE33461DB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66505-BB2C-40BD-A9E4-BC1351537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928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B1FB0-4F85-4F5C-ACEF-5DBE33461DB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66505-BB2C-40BD-A9E4-BC1351537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7848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B1FB0-4F85-4F5C-ACEF-5DBE33461DB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66505-BB2C-40BD-A9E4-BC1351537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5132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B1FB0-4F85-4F5C-ACEF-5DBE33461DB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66505-BB2C-40BD-A9E4-BC1351537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61415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B1FB0-4F85-4F5C-ACEF-5DBE33461DB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66505-BB2C-40BD-A9E4-BC1351537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0769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B1FB0-4F85-4F5C-ACEF-5DBE33461DB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66505-BB2C-40BD-A9E4-BC1351537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3685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B1FB0-4F85-4F5C-ACEF-5DBE33461DB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66505-BB2C-40BD-A9E4-BC1351537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172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B1FB0-4F85-4F5C-ACEF-5DBE33461DB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766505-BB2C-40BD-A9E4-BC1351537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6574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A0DA2137-566A-47C9-831C-3B7A56581B0F}"/>
              </a:ext>
            </a:extLst>
          </p:cNvPr>
          <p:cNvGrpSpPr/>
          <p:nvPr/>
        </p:nvGrpSpPr>
        <p:grpSpPr>
          <a:xfrm>
            <a:off x="881887" y="2347008"/>
            <a:ext cx="5441228" cy="1293060"/>
            <a:chOff x="881887" y="2347008"/>
            <a:chExt cx="5441228" cy="129306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5EC49F6-219D-E145-BE91-C5E0D029AC4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49560" y="2347008"/>
              <a:ext cx="4399973" cy="1233465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9A54A5B-6AE9-314A-8307-D212602364CA}"/>
                </a:ext>
              </a:extLst>
            </p:cNvPr>
            <p:cNvSpPr txBox="1"/>
            <p:nvPr/>
          </p:nvSpPr>
          <p:spPr>
            <a:xfrm>
              <a:off x="5649533" y="2807979"/>
              <a:ext cx="6735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RAF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A85D9D5-9222-B740-9289-D4E1D907DA1F}"/>
                </a:ext>
              </a:extLst>
            </p:cNvPr>
            <p:cNvSpPr txBox="1"/>
            <p:nvPr/>
          </p:nvSpPr>
          <p:spPr>
            <a:xfrm>
              <a:off x="881887" y="2456366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250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931972C-CD92-5141-BC00-4EFE04BE0F01}"/>
                </a:ext>
              </a:extLst>
            </p:cNvPr>
            <p:cNvSpPr txBox="1"/>
            <p:nvPr/>
          </p:nvSpPr>
          <p:spPr>
            <a:xfrm>
              <a:off x="881887" y="2742697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150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E27CCA3-D9D3-E246-A3FA-96F59DB7E6D3}"/>
                </a:ext>
              </a:extLst>
            </p:cNvPr>
            <p:cNvSpPr txBox="1"/>
            <p:nvPr/>
          </p:nvSpPr>
          <p:spPr>
            <a:xfrm>
              <a:off x="881887" y="3089977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10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F0DF9BD-3E6F-934E-8361-5251D41C6100}"/>
                </a:ext>
              </a:extLst>
            </p:cNvPr>
            <p:cNvSpPr txBox="1"/>
            <p:nvPr/>
          </p:nvSpPr>
          <p:spPr>
            <a:xfrm>
              <a:off x="968345" y="3378458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75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5F7343A3-C888-4CB2-AAF6-C6FA1AA999C5}"/>
              </a:ext>
            </a:extLst>
          </p:cNvPr>
          <p:cNvGrpSpPr/>
          <p:nvPr/>
        </p:nvGrpSpPr>
        <p:grpSpPr>
          <a:xfrm>
            <a:off x="881887" y="3815522"/>
            <a:ext cx="5537677" cy="757989"/>
            <a:chOff x="881887" y="3815522"/>
            <a:chExt cx="5537677" cy="757989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B22CD7D7-DBC0-BC4C-A3A7-7DA731393C9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49560" y="3826909"/>
              <a:ext cx="4399973" cy="746602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EFE7AFA-80D1-C643-ACE6-7F013CF65D78}"/>
                </a:ext>
              </a:extLst>
            </p:cNvPr>
            <p:cNvSpPr txBox="1"/>
            <p:nvPr/>
          </p:nvSpPr>
          <p:spPr>
            <a:xfrm>
              <a:off x="5624153" y="4028899"/>
              <a:ext cx="7954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pBRAF</a:t>
              </a:r>
              <a:endParaRPr lang="en-US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9AD05F4-7471-3D4E-B1A6-FC7FAA069EB4}"/>
                </a:ext>
              </a:extLst>
            </p:cNvPr>
            <p:cNvSpPr txBox="1"/>
            <p:nvPr/>
          </p:nvSpPr>
          <p:spPr>
            <a:xfrm>
              <a:off x="881887" y="3815522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10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388256F-1B40-F549-8C37-6FE79F6A6176}"/>
                </a:ext>
              </a:extLst>
            </p:cNvPr>
            <p:cNvSpPr txBox="1"/>
            <p:nvPr/>
          </p:nvSpPr>
          <p:spPr>
            <a:xfrm>
              <a:off x="954023" y="4189222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75</a:t>
              </a: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2865BFDA-1A5E-41BE-8E5A-7BD0797FDE13}"/>
              </a:ext>
            </a:extLst>
          </p:cNvPr>
          <p:cNvGrpSpPr/>
          <p:nvPr/>
        </p:nvGrpSpPr>
        <p:grpSpPr>
          <a:xfrm>
            <a:off x="963570" y="4729929"/>
            <a:ext cx="5316134" cy="1375467"/>
            <a:chOff x="963570" y="4729929"/>
            <a:chExt cx="5316134" cy="1375467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887EC7A4-B255-5847-9087-AA7466929DA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34121" y="4729929"/>
              <a:ext cx="4415412" cy="1375467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77D00CE-2B0A-C946-820C-F3EEFD880068}"/>
                </a:ext>
              </a:extLst>
            </p:cNvPr>
            <p:cNvSpPr txBox="1"/>
            <p:nvPr/>
          </p:nvSpPr>
          <p:spPr>
            <a:xfrm>
              <a:off x="963570" y="5010642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5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33720A9-DE46-764C-9F47-10615B58D741}"/>
                </a:ext>
              </a:extLst>
            </p:cNvPr>
            <p:cNvSpPr txBox="1"/>
            <p:nvPr/>
          </p:nvSpPr>
          <p:spPr>
            <a:xfrm>
              <a:off x="984299" y="5605118"/>
              <a:ext cx="3650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37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7FBB247-0725-DB4D-B21A-85A09E87E8EF}"/>
                </a:ext>
              </a:extLst>
            </p:cNvPr>
            <p:cNvSpPr txBox="1"/>
            <p:nvPr/>
          </p:nvSpPr>
          <p:spPr>
            <a:xfrm>
              <a:off x="5665433" y="5249819"/>
              <a:ext cx="6142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MEK</a:t>
              </a:r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CE4AB8B9-3222-4945-846F-1C90D877CAAF}"/>
              </a:ext>
            </a:extLst>
          </p:cNvPr>
          <p:cNvGrpSpPr/>
          <p:nvPr/>
        </p:nvGrpSpPr>
        <p:grpSpPr>
          <a:xfrm>
            <a:off x="888372" y="6295394"/>
            <a:ext cx="5495879" cy="1080980"/>
            <a:chOff x="888372" y="6295394"/>
            <a:chExt cx="5495879" cy="1080980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C8975C20-8CDF-7C4D-9218-81D1C4F611E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241302" y="6295394"/>
              <a:ext cx="4375396" cy="1080980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7D491E8-53B4-5E42-99DA-15928F7696F2}"/>
                </a:ext>
              </a:extLst>
            </p:cNvPr>
            <p:cNvSpPr txBox="1"/>
            <p:nvPr/>
          </p:nvSpPr>
          <p:spPr>
            <a:xfrm>
              <a:off x="888372" y="6465761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5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0DEB92B-E5CE-EA48-B3C0-39580C92858B}"/>
                </a:ext>
              </a:extLst>
            </p:cNvPr>
            <p:cNvSpPr txBox="1"/>
            <p:nvPr/>
          </p:nvSpPr>
          <p:spPr>
            <a:xfrm>
              <a:off x="909101" y="7060237"/>
              <a:ext cx="3650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37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DB63580-8CDB-6D43-A2D4-0449CAECC3B6}"/>
                </a:ext>
              </a:extLst>
            </p:cNvPr>
            <p:cNvSpPr txBox="1"/>
            <p:nvPr/>
          </p:nvSpPr>
          <p:spPr>
            <a:xfrm>
              <a:off x="5648152" y="6584313"/>
              <a:ext cx="7360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pMEK</a:t>
              </a:r>
              <a:endParaRPr lang="en-US" dirty="0"/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7DD23E12-B11C-4956-971D-8D23B938827E}"/>
              </a:ext>
            </a:extLst>
          </p:cNvPr>
          <p:cNvGrpSpPr/>
          <p:nvPr/>
        </p:nvGrpSpPr>
        <p:grpSpPr>
          <a:xfrm>
            <a:off x="825914" y="7529443"/>
            <a:ext cx="5316139" cy="1027706"/>
            <a:chOff x="825914" y="7529443"/>
            <a:chExt cx="5316139" cy="1027706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7855DC39-9DC3-4343-AED1-6EF428B7E32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047179" y="7529443"/>
              <a:ext cx="4552738" cy="1027706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1A57A1A-DB32-444F-B074-809767F1405F}"/>
                </a:ext>
              </a:extLst>
            </p:cNvPr>
            <p:cNvSpPr txBox="1"/>
            <p:nvPr/>
          </p:nvSpPr>
          <p:spPr>
            <a:xfrm>
              <a:off x="825914" y="7620047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5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E7E2703-579E-9D41-B2EF-A3CF4D819ED6}"/>
                </a:ext>
              </a:extLst>
            </p:cNvPr>
            <p:cNvSpPr txBox="1"/>
            <p:nvPr/>
          </p:nvSpPr>
          <p:spPr>
            <a:xfrm>
              <a:off x="846643" y="8214523"/>
              <a:ext cx="3650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37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171F4DD-CA73-9B4F-A184-FA6EA470C326}"/>
                </a:ext>
              </a:extLst>
            </p:cNvPr>
            <p:cNvSpPr txBox="1"/>
            <p:nvPr/>
          </p:nvSpPr>
          <p:spPr>
            <a:xfrm>
              <a:off x="5599917" y="7894216"/>
              <a:ext cx="5421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ERK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65DD8315-60E8-46FA-95B1-BB52E31D91A5}"/>
              </a:ext>
            </a:extLst>
          </p:cNvPr>
          <p:cNvSpPr txBox="1"/>
          <p:nvPr/>
        </p:nvSpPr>
        <p:spPr>
          <a:xfrm>
            <a:off x="665758" y="1182835"/>
            <a:ext cx="45148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ull images for Fig. 2b (to be continued on the next page)</a:t>
            </a:r>
          </a:p>
        </p:txBody>
      </p:sp>
    </p:spTree>
    <p:extLst>
      <p:ext uri="{BB962C8B-B14F-4D97-AF65-F5344CB8AC3E}">
        <p14:creationId xmlns:p14="http://schemas.microsoft.com/office/powerpoint/2010/main" val="10219377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09500384-D3AB-49A3-B481-717BE5309AC7}"/>
              </a:ext>
            </a:extLst>
          </p:cNvPr>
          <p:cNvGrpSpPr/>
          <p:nvPr/>
        </p:nvGrpSpPr>
        <p:grpSpPr>
          <a:xfrm>
            <a:off x="713686" y="1705261"/>
            <a:ext cx="5513089" cy="1242255"/>
            <a:chOff x="713686" y="1705261"/>
            <a:chExt cx="5513089" cy="1242255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BB84F52B-EFD9-49DA-9EB1-EAE67A9AB20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39728" y="1705261"/>
              <a:ext cx="4523083" cy="1242255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B90F0BBA-ED36-4F80-8A3A-DF11AD72FBAC}"/>
                </a:ext>
              </a:extLst>
            </p:cNvPr>
            <p:cNvSpPr txBox="1"/>
            <p:nvPr/>
          </p:nvSpPr>
          <p:spPr>
            <a:xfrm>
              <a:off x="5562811" y="2051554"/>
              <a:ext cx="6639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pERK</a:t>
              </a:r>
              <a:endParaRPr lang="en-US" dirty="0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FB7ADCD-2462-4991-A76D-F31D81417229}"/>
                </a:ext>
              </a:extLst>
            </p:cNvPr>
            <p:cNvSpPr txBox="1"/>
            <p:nvPr/>
          </p:nvSpPr>
          <p:spPr>
            <a:xfrm>
              <a:off x="713686" y="1948598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50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8410181-45C3-45D5-B797-7E3741A6A8F5}"/>
                </a:ext>
              </a:extLst>
            </p:cNvPr>
            <p:cNvSpPr txBox="1"/>
            <p:nvPr/>
          </p:nvSpPr>
          <p:spPr>
            <a:xfrm>
              <a:off x="734415" y="2543074"/>
              <a:ext cx="3650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37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F9DBE90D-4510-4F5D-96B7-EE093706BF76}"/>
              </a:ext>
            </a:extLst>
          </p:cNvPr>
          <p:cNvGrpSpPr/>
          <p:nvPr/>
        </p:nvGrpSpPr>
        <p:grpSpPr>
          <a:xfrm>
            <a:off x="692957" y="3069337"/>
            <a:ext cx="5608039" cy="1011719"/>
            <a:chOff x="692957" y="3069337"/>
            <a:chExt cx="5608039" cy="1011719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079E95FB-7C98-40DE-A59E-6E7DB3E8277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10073" y="3069337"/>
              <a:ext cx="4552738" cy="1011719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7209F52-BF15-4D17-8B22-EBD717F4862E}"/>
                </a:ext>
              </a:extLst>
            </p:cNvPr>
            <p:cNvSpPr txBox="1"/>
            <p:nvPr/>
          </p:nvSpPr>
          <p:spPr>
            <a:xfrm>
              <a:off x="692957" y="3210535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5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3F6974A-2734-47AA-BE59-135EBD609408}"/>
                </a:ext>
              </a:extLst>
            </p:cNvPr>
            <p:cNvSpPr txBox="1"/>
            <p:nvPr/>
          </p:nvSpPr>
          <p:spPr>
            <a:xfrm>
              <a:off x="713686" y="3805011"/>
              <a:ext cx="3650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37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381117A-791D-445D-8A0C-787FB5122A03}"/>
                </a:ext>
              </a:extLst>
            </p:cNvPr>
            <p:cNvSpPr txBox="1"/>
            <p:nvPr/>
          </p:nvSpPr>
          <p:spPr>
            <a:xfrm>
              <a:off x="5656268" y="3390530"/>
              <a:ext cx="6447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ctin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3776D2BF-941B-457B-A6AD-748E6CA2AE49}"/>
              </a:ext>
            </a:extLst>
          </p:cNvPr>
          <p:cNvSpPr txBox="1"/>
          <p:nvPr/>
        </p:nvSpPr>
        <p:spPr>
          <a:xfrm>
            <a:off x="692957" y="783426"/>
            <a:ext cx="4514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ull images for Fig. 2b (continued)</a:t>
            </a:r>
          </a:p>
        </p:txBody>
      </p:sp>
    </p:spTree>
    <p:extLst>
      <p:ext uri="{BB962C8B-B14F-4D97-AF65-F5344CB8AC3E}">
        <p14:creationId xmlns:p14="http://schemas.microsoft.com/office/powerpoint/2010/main" val="16996354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Group 42">
            <a:extLst>
              <a:ext uri="{FF2B5EF4-FFF2-40B4-BE49-F238E27FC236}">
                <a16:creationId xmlns:a16="http://schemas.microsoft.com/office/drawing/2014/main" id="{7949CBDA-8F93-4F7F-ACE2-B1E9ED13FA5A}"/>
              </a:ext>
            </a:extLst>
          </p:cNvPr>
          <p:cNvGrpSpPr/>
          <p:nvPr/>
        </p:nvGrpSpPr>
        <p:grpSpPr>
          <a:xfrm>
            <a:off x="1259621" y="1626708"/>
            <a:ext cx="3663446" cy="1729223"/>
            <a:chOff x="1259621" y="1626708"/>
            <a:chExt cx="3663446" cy="1729223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33D70724-B161-1C48-9ACD-4424AA82342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75828" y="1626708"/>
              <a:ext cx="1755423" cy="1729223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F91183AB-1325-BC43-9FAE-68C3142B484F}"/>
                </a:ext>
              </a:extLst>
            </p:cNvPr>
            <p:cNvSpPr txBox="1"/>
            <p:nvPr/>
          </p:nvSpPr>
          <p:spPr>
            <a:xfrm>
              <a:off x="3807056" y="2236627"/>
              <a:ext cx="11160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aspase 3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D88C914-68B0-B248-95C7-B4E4AC9D581D}"/>
                </a:ext>
              </a:extLst>
            </p:cNvPr>
            <p:cNvSpPr txBox="1"/>
            <p:nvPr/>
          </p:nvSpPr>
          <p:spPr>
            <a:xfrm>
              <a:off x="1259621" y="1707591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50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D773EE4E-8414-634F-8153-B754FAC828E7}"/>
                </a:ext>
              </a:extLst>
            </p:cNvPr>
            <p:cNvSpPr txBox="1"/>
            <p:nvPr/>
          </p:nvSpPr>
          <p:spPr>
            <a:xfrm>
              <a:off x="1259621" y="1969371"/>
              <a:ext cx="3650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37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1C5E6F43-3662-A041-908C-62BF7E1A95FA}"/>
                </a:ext>
              </a:extLst>
            </p:cNvPr>
            <p:cNvSpPr txBox="1"/>
            <p:nvPr/>
          </p:nvSpPr>
          <p:spPr>
            <a:xfrm>
              <a:off x="1265332" y="2344349"/>
              <a:ext cx="3650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25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F18E7FB-AB17-484A-962C-AA1D5975AAEF}"/>
                </a:ext>
              </a:extLst>
            </p:cNvPr>
            <p:cNvSpPr txBox="1"/>
            <p:nvPr/>
          </p:nvSpPr>
          <p:spPr>
            <a:xfrm>
              <a:off x="1267564" y="2554789"/>
              <a:ext cx="3650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2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7B255A8-EED5-B34E-A4FC-8F9F8A3D96BB}"/>
                </a:ext>
              </a:extLst>
            </p:cNvPr>
            <p:cNvSpPr txBox="1"/>
            <p:nvPr/>
          </p:nvSpPr>
          <p:spPr>
            <a:xfrm>
              <a:off x="1290846" y="3054112"/>
              <a:ext cx="3650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15</a:t>
              </a:r>
            </a:p>
          </p:txBody>
        </p: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E4AD5C61-39CA-43EE-97D1-D90B7929A7B6}"/>
              </a:ext>
            </a:extLst>
          </p:cNvPr>
          <p:cNvSpPr txBox="1"/>
          <p:nvPr/>
        </p:nvSpPr>
        <p:spPr>
          <a:xfrm>
            <a:off x="512561" y="435616"/>
            <a:ext cx="4514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ull images for Fig. 3d</a:t>
            </a:r>
          </a:p>
        </p:txBody>
      </p:sp>
      <p:grpSp>
        <p:nvGrpSpPr>
          <p:cNvPr id="45" name="Group 44">
            <a:extLst>
              <a:ext uri="{FF2B5EF4-FFF2-40B4-BE49-F238E27FC236}">
                <a16:creationId xmlns:a16="http://schemas.microsoft.com/office/drawing/2014/main" id="{8E5815B7-B5EC-4BBE-A0BE-D2E0B08B21DC}"/>
              </a:ext>
            </a:extLst>
          </p:cNvPr>
          <p:cNvGrpSpPr/>
          <p:nvPr/>
        </p:nvGrpSpPr>
        <p:grpSpPr>
          <a:xfrm>
            <a:off x="1157124" y="6227986"/>
            <a:ext cx="4935712" cy="1743969"/>
            <a:chOff x="1157124" y="6227986"/>
            <a:chExt cx="4935712" cy="1743969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174A7CD6-08ED-458D-91CF-0E54D993DABE}"/>
                </a:ext>
              </a:extLst>
            </p:cNvPr>
            <p:cNvSpPr txBox="1"/>
            <p:nvPr/>
          </p:nvSpPr>
          <p:spPr>
            <a:xfrm>
              <a:off x="1157124" y="6227986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50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D852542F-1A6F-43D3-9F0F-2564791A82B2}"/>
                </a:ext>
              </a:extLst>
            </p:cNvPr>
            <p:cNvSpPr txBox="1"/>
            <p:nvPr/>
          </p:nvSpPr>
          <p:spPr>
            <a:xfrm>
              <a:off x="1157124" y="6842662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35</a:t>
              </a:r>
            </a:p>
          </p:txBody>
        </p:sp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9AA5E3A9-6B20-43ED-9FC6-AF8D83485E6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75828" y="6342206"/>
              <a:ext cx="2716248" cy="1629749"/>
            </a:xfrm>
            <a:prstGeom prst="rect">
              <a:avLst/>
            </a:prstGeom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12FCCD79-3485-40E7-8829-3BC2E6457CD7}"/>
                </a:ext>
              </a:extLst>
            </p:cNvPr>
            <p:cNvSpPr txBox="1"/>
            <p:nvPr/>
          </p:nvSpPr>
          <p:spPr>
            <a:xfrm>
              <a:off x="1157124" y="7396661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5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C38A5DEB-B15E-483D-9CA4-5BC4C020DF9F}"/>
                </a:ext>
              </a:extLst>
            </p:cNvPr>
            <p:cNvSpPr txBox="1"/>
            <p:nvPr/>
          </p:nvSpPr>
          <p:spPr>
            <a:xfrm>
              <a:off x="4471508" y="6945456"/>
              <a:ext cx="162132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/>
                <a:t>Caspase 9</a:t>
              </a:r>
            </a:p>
          </p:txBody>
        </p: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D089A0CC-708D-485A-A988-5D343A61C7A3}"/>
              </a:ext>
            </a:extLst>
          </p:cNvPr>
          <p:cNvGrpSpPr/>
          <p:nvPr/>
        </p:nvGrpSpPr>
        <p:grpSpPr>
          <a:xfrm>
            <a:off x="974538" y="4221232"/>
            <a:ext cx="5004231" cy="1404932"/>
            <a:chOff x="974538" y="4221232"/>
            <a:chExt cx="5004231" cy="1404932"/>
          </a:xfrm>
        </p:grpSpPr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BBBBC274-092E-4DDC-8044-EEA367962D1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380696" y="4222611"/>
              <a:ext cx="3047714" cy="1403553"/>
            </a:xfrm>
            <a:prstGeom prst="rect">
              <a:avLst/>
            </a:prstGeom>
          </p:spPr>
        </p:pic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2497945-F996-4E63-9679-78462B979FAF}"/>
                </a:ext>
              </a:extLst>
            </p:cNvPr>
            <p:cNvSpPr txBox="1"/>
            <p:nvPr/>
          </p:nvSpPr>
          <p:spPr>
            <a:xfrm>
              <a:off x="974538" y="4221232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35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DB107D4-502F-4318-A86A-A029FB4353DD}"/>
                </a:ext>
              </a:extLst>
            </p:cNvPr>
            <p:cNvSpPr txBox="1"/>
            <p:nvPr/>
          </p:nvSpPr>
          <p:spPr>
            <a:xfrm>
              <a:off x="1014134" y="4797916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5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B12BA7DF-A288-4DC1-8BB9-CAEB4CEC8505}"/>
                </a:ext>
              </a:extLst>
            </p:cNvPr>
            <p:cNvSpPr txBox="1"/>
            <p:nvPr/>
          </p:nvSpPr>
          <p:spPr>
            <a:xfrm>
              <a:off x="4789688" y="4601221"/>
              <a:ext cx="118908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/>
                <a:t>Caspase 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197557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C5404ED-5933-417F-AAA4-8FEA69C242E6}"/>
              </a:ext>
            </a:extLst>
          </p:cNvPr>
          <p:cNvSpPr txBox="1"/>
          <p:nvPr/>
        </p:nvSpPr>
        <p:spPr>
          <a:xfrm>
            <a:off x="923192" y="738526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Full images for Fig. 3d (continued)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3387D589-C3EB-431B-910A-14B143EE2503}"/>
              </a:ext>
            </a:extLst>
          </p:cNvPr>
          <p:cNvGrpSpPr/>
          <p:nvPr/>
        </p:nvGrpSpPr>
        <p:grpSpPr>
          <a:xfrm>
            <a:off x="1155268" y="1884836"/>
            <a:ext cx="4005300" cy="1887063"/>
            <a:chOff x="1155268" y="1884836"/>
            <a:chExt cx="4005300" cy="1887063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E6AA93B8-1AB0-488B-868C-2ABB2AB1AF6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56590" y="1884836"/>
              <a:ext cx="2399265" cy="1887063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A3F77CB-CF7C-49BF-8B54-3CAA04BA786F}"/>
                </a:ext>
              </a:extLst>
            </p:cNvPr>
            <p:cNvSpPr txBox="1"/>
            <p:nvPr/>
          </p:nvSpPr>
          <p:spPr>
            <a:xfrm>
              <a:off x="4258978" y="2735966"/>
              <a:ext cx="90159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PARP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112A48B-B363-4DE6-870C-6D188E5D35E5}"/>
                </a:ext>
              </a:extLst>
            </p:cNvPr>
            <p:cNvSpPr txBox="1"/>
            <p:nvPr/>
          </p:nvSpPr>
          <p:spPr>
            <a:xfrm>
              <a:off x="1176780" y="1941316"/>
              <a:ext cx="54540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25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D55B672-AD6A-4558-90EA-35B05842F8C2}"/>
                </a:ext>
              </a:extLst>
            </p:cNvPr>
            <p:cNvSpPr txBox="1"/>
            <p:nvPr/>
          </p:nvSpPr>
          <p:spPr>
            <a:xfrm>
              <a:off x="1172462" y="2329266"/>
              <a:ext cx="54540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15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6887710-8411-49AB-963E-93DF95233DB6}"/>
                </a:ext>
              </a:extLst>
            </p:cNvPr>
            <p:cNvSpPr txBox="1"/>
            <p:nvPr/>
          </p:nvSpPr>
          <p:spPr>
            <a:xfrm>
              <a:off x="1155268" y="2814141"/>
              <a:ext cx="54540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10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A3B94C4-E696-4412-B28B-689E55FD57D4}"/>
                </a:ext>
              </a:extLst>
            </p:cNvPr>
            <p:cNvSpPr txBox="1"/>
            <p:nvPr/>
          </p:nvSpPr>
          <p:spPr>
            <a:xfrm>
              <a:off x="1226857" y="3226744"/>
              <a:ext cx="44730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75</a:t>
              </a: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58741701-A41A-4650-8DA9-FB917FCC200B}"/>
              </a:ext>
            </a:extLst>
          </p:cNvPr>
          <p:cNvGrpSpPr/>
          <p:nvPr/>
        </p:nvGrpSpPr>
        <p:grpSpPr>
          <a:xfrm>
            <a:off x="1106976" y="4733406"/>
            <a:ext cx="4247075" cy="1597055"/>
            <a:chOff x="1106976" y="4733406"/>
            <a:chExt cx="4247075" cy="1597055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FFEF34D-088B-4C29-999F-BC816AE63A50}"/>
                </a:ext>
              </a:extLst>
            </p:cNvPr>
            <p:cNvSpPr txBox="1"/>
            <p:nvPr/>
          </p:nvSpPr>
          <p:spPr>
            <a:xfrm>
              <a:off x="1106976" y="4773782"/>
              <a:ext cx="5111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50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F834FF43-FD49-42BD-A591-2512FC95C82B}"/>
                </a:ext>
              </a:extLst>
            </p:cNvPr>
            <p:cNvSpPr txBox="1"/>
            <p:nvPr/>
          </p:nvSpPr>
          <p:spPr>
            <a:xfrm>
              <a:off x="1106976" y="5802065"/>
              <a:ext cx="5671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37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C5DC11C-90E7-4AB2-A196-6C85394E4D92}"/>
                </a:ext>
              </a:extLst>
            </p:cNvPr>
            <p:cNvSpPr txBox="1"/>
            <p:nvPr/>
          </p:nvSpPr>
          <p:spPr>
            <a:xfrm>
              <a:off x="4352192" y="5240982"/>
              <a:ext cx="10018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ctin</a:t>
              </a: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1E09CC59-1F50-4BE8-B7B3-E2AD4951DCA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79202" y="4733406"/>
              <a:ext cx="2693072" cy="159705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667303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>
            <a:extLst>
              <a:ext uri="{FF2B5EF4-FFF2-40B4-BE49-F238E27FC236}">
                <a16:creationId xmlns:a16="http://schemas.microsoft.com/office/drawing/2014/main" id="{992D769D-86FC-4B5E-9D16-9C8467067451}"/>
              </a:ext>
            </a:extLst>
          </p:cNvPr>
          <p:cNvGrpSpPr/>
          <p:nvPr/>
        </p:nvGrpSpPr>
        <p:grpSpPr>
          <a:xfrm>
            <a:off x="1300707" y="4306562"/>
            <a:ext cx="4511311" cy="1645936"/>
            <a:chOff x="1300707" y="4306562"/>
            <a:chExt cx="4511311" cy="1645936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AEEBBE12-20A1-A241-8D6B-B84D206CE31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15683" y="4306562"/>
              <a:ext cx="3715113" cy="1645936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C26CAD95-79D4-AB4E-89C3-1767C3EF615F}"/>
                </a:ext>
              </a:extLst>
            </p:cNvPr>
            <p:cNvSpPr txBox="1"/>
            <p:nvPr/>
          </p:nvSpPr>
          <p:spPr>
            <a:xfrm>
              <a:off x="5330796" y="4944864"/>
              <a:ext cx="4812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Erk</a:t>
              </a:r>
              <a:endParaRPr lang="en-US" dirty="0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5742B77-656C-0B48-8C29-0976D023A5D3}"/>
                </a:ext>
              </a:extLst>
            </p:cNvPr>
            <p:cNvSpPr txBox="1"/>
            <p:nvPr/>
          </p:nvSpPr>
          <p:spPr>
            <a:xfrm>
              <a:off x="1300707" y="4697160"/>
              <a:ext cx="35828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50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DCCA2FB-F48B-A34D-BA45-61E45D3AFF4B}"/>
                </a:ext>
              </a:extLst>
            </p:cNvPr>
            <p:cNvSpPr txBox="1"/>
            <p:nvPr/>
          </p:nvSpPr>
          <p:spPr>
            <a:xfrm>
              <a:off x="1300707" y="5295941"/>
              <a:ext cx="35828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37</a:t>
              </a: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F494A336-4B8A-4166-A4B3-6A80664E8E3E}"/>
              </a:ext>
            </a:extLst>
          </p:cNvPr>
          <p:cNvGrpSpPr/>
          <p:nvPr/>
        </p:nvGrpSpPr>
        <p:grpSpPr>
          <a:xfrm>
            <a:off x="1323472" y="6058504"/>
            <a:ext cx="4622958" cy="1532484"/>
            <a:chOff x="1323472" y="6058504"/>
            <a:chExt cx="4622958" cy="1532484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7EB582C-4C73-BD4A-97DF-69A23CAF7AD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28266" y="6058504"/>
              <a:ext cx="3715113" cy="1532484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08CA01F-3427-FB43-8D63-B10DD365DDFB}"/>
                </a:ext>
              </a:extLst>
            </p:cNvPr>
            <p:cNvSpPr txBox="1"/>
            <p:nvPr/>
          </p:nvSpPr>
          <p:spPr>
            <a:xfrm>
              <a:off x="5343380" y="6645964"/>
              <a:ext cx="6030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pErk</a:t>
              </a:r>
              <a:endParaRPr lang="en-US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63803D4-BE0D-F24D-8D41-F6999FE152D0}"/>
                </a:ext>
              </a:extLst>
            </p:cNvPr>
            <p:cNvSpPr txBox="1"/>
            <p:nvPr/>
          </p:nvSpPr>
          <p:spPr>
            <a:xfrm>
              <a:off x="1323472" y="6456120"/>
              <a:ext cx="35828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5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F14125A-2CE1-D44C-9697-4970029F2EE8}"/>
                </a:ext>
              </a:extLst>
            </p:cNvPr>
            <p:cNvSpPr txBox="1"/>
            <p:nvPr/>
          </p:nvSpPr>
          <p:spPr>
            <a:xfrm>
              <a:off x="1323472" y="7054901"/>
              <a:ext cx="35828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37</a:t>
              </a:r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E5A91DA2-5F03-424C-9DCD-9E0641E65689}"/>
              </a:ext>
            </a:extLst>
          </p:cNvPr>
          <p:cNvGrpSpPr/>
          <p:nvPr/>
        </p:nvGrpSpPr>
        <p:grpSpPr>
          <a:xfrm>
            <a:off x="1323472" y="1097687"/>
            <a:ext cx="4712795" cy="1566614"/>
            <a:chOff x="1323472" y="1097687"/>
            <a:chExt cx="4712795" cy="1566614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A8584C3C-0F7F-E044-AA5E-2FD13780D74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573382" y="1097687"/>
              <a:ext cx="3715113" cy="1566614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697878B-95E4-6644-B0F7-5B773F6B9D9F}"/>
                </a:ext>
              </a:extLst>
            </p:cNvPr>
            <p:cNvSpPr txBox="1"/>
            <p:nvPr/>
          </p:nvSpPr>
          <p:spPr>
            <a:xfrm>
              <a:off x="5421996" y="1696328"/>
              <a:ext cx="6142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MEK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F19036B-C1B0-B74F-B303-36DEFCC54489}"/>
                </a:ext>
              </a:extLst>
            </p:cNvPr>
            <p:cNvSpPr txBox="1"/>
            <p:nvPr/>
          </p:nvSpPr>
          <p:spPr>
            <a:xfrm>
              <a:off x="1323472" y="1499920"/>
              <a:ext cx="35828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5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FF3E9D9-1254-4446-B3EE-C3F15DA79872}"/>
                </a:ext>
              </a:extLst>
            </p:cNvPr>
            <p:cNvSpPr txBox="1"/>
            <p:nvPr/>
          </p:nvSpPr>
          <p:spPr>
            <a:xfrm>
              <a:off x="1346236" y="2000050"/>
              <a:ext cx="35828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37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1843223E-3B02-476C-BE48-1C44B829C47E}"/>
              </a:ext>
            </a:extLst>
          </p:cNvPr>
          <p:cNvGrpSpPr/>
          <p:nvPr/>
        </p:nvGrpSpPr>
        <p:grpSpPr>
          <a:xfrm>
            <a:off x="1303039" y="2764475"/>
            <a:ext cx="4897358" cy="1467699"/>
            <a:chOff x="1303039" y="2764475"/>
            <a:chExt cx="4897358" cy="1467699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851DAF00-9B61-6648-A0F6-55095EDAACB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615683" y="2764475"/>
              <a:ext cx="3715113" cy="1467699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D1CA7D2-DE8C-2E40-9CA0-C9A40DCEBF4C}"/>
                </a:ext>
              </a:extLst>
            </p:cNvPr>
            <p:cNvSpPr txBox="1"/>
            <p:nvPr/>
          </p:nvSpPr>
          <p:spPr>
            <a:xfrm>
              <a:off x="5464298" y="3313658"/>
              <a:ext cx="7360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pMEK</a:t>
              </a:r>
              <a:endParaRPr lang="en-US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64FD84F-4A6E-E945-9EE9-1803B3725B22}"/>
                </a:ext>
              </a:extLst>
            </p:cNvPr>
            <p:cNvSpPr txBox="1"/>
            <p:nvPr/>
          </p:nvSpPr>
          <p:spPr>
            <a:xfrm>
              <a:off x="1303039" y="3148136"/>
              <a:ext cx="35828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5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54EE272-B40B-6844-B19A-DE32C492718B}"/>
                </a:ext>
              </a:extLst>
            </p:cNvPr>
            <p:cNvSpPr txBox="1"/>
            <p:nvPr/>
          </p:nvSpPr>
          <p:spPr>
            <a:xfrm>
              <a:off x="1325803" y="3648266"/>
              <a:ext cx="35828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37</a:t>
              </a: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662D7A17-CF99-402B-8CF9-36636D075881}"/>
              </a:ext>
            </a:extLst>
          </p:cNvPr>
          <p:cNvGrpSpPr/>
          <p:nvPr/>
        </p:nvGrpSpPr>
        <p:grpSpPr>
          <a:xfrm>
            <a:off x="1300707" y="7675332"/>
            <a:ext cx="4788892" cy="1286508"/>
            <a:chOff x="1300707" y="7675332"/>
            <a:chExt cx="4788892" cy="1286508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1D944E45-375D-6D40-8F45-75108758112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628266" y="7739764"/>
              <a:ext cx="3715112" cy="1222076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DAADCC2-66D1-7445-9A5A-5E2BCBF63FC7}"/>
                </a:ext>
              </a:extLst>
            </p:cNvPr>
            <p:cNvSpPr txBox="1"/>
            <p:nvPr/>
          </p:nvSpPr>
          <p:spPr>
            <a:xfrm>
              <a:off x="5444871" y="8166136"/>
              <a:ext cx="6447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ctin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1A3FB0E-BA57-B94D-A376-8DC64D1E6D2A}"/>
                </a:ext>
              </a:extLst>
            </p:cNvPr>
            <p:cNvSpPr txBox="1"/>
            <p:nvPr/>
          </p:nvSpPr>
          <p:spPr>
            <a:xfrm>
              <a:off x="1300707" y="7675332"/>
              <a:ext cx="35828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50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77F06393-5C12-6747-B858-6CD7EED8C2D5}"/>
                </a:ext>
              </a:extLst>
            </p:cNvPr>
            <p:cNvSpPr txBox="1"/>
            <p:nvPr/>
          </p:nvSpPr>
          <p:spPr>
            <a:xfrm>
              <a:off x="1347631" y="8360266"/>
              <a:ext cx="35828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37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C9052F2B-9CD7-41A8-896B-94F70BA20A0A}"/>
              </a:ext>
            </a:extLst>
          </p:cNvPr>
          <p:cNvSpPr txBox="1"/>
          <p:nvPr/>
        </p:nvSpPr>
        <p:spPr>
          <a:xfrm>
            <a:off x="620486" y="700296"/>
            <a:ext cx="4514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ull images for Fig. 5.</a:t>
            </a:r>
          </a:p>
        </p:txBody>
      </p:sp>
    </p:spTree>
    <p:extLst>
      <p:ext uri="{BB962C8B-B14F-4D97-AF65-F5344CB8AC3E}">
        <p14:creationId xmlns:p14="http://schemas.microsoft.com/office/powerpoint/2010/main" val="19647107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412873AD-0442-478C-A018-5362D6D3E99A}"/>
              </a:ext>
            </a:extLst>
          </p:cNvPr>
          <p:cNvGrpSpPr/>
          <p:nvPr/>
        </p:nvGrpSpPr>
        <p:grpSpPr>
          <a:xfrm>
            <a:off x="1093675" y="6956980"/>
            <a:ext cx="2862342" cy="1243949"/>
            <a:chOff x="1093675" y="6956980"/>
            <a:chExt cx="2862342" cy="1243949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8608ECDC-DD75-D84B-AF1C-B8A8FC70EAF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30322" y="6956980"/>
              <a:ext cx="1880967" cy="1235262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1776006C-BEF8-2644-AF2E-7C5C3B99DE10}"/>
                </a:ext>
              </a:extLst>
            </p:cNvPr>
            <p:cNvSpPr txBox="1"/>
            <p:nvPr/>
          </p:nvSpPr>
          <p:spPr>
            <a:xfrm>
              <a:off x="3311289" y="7389945"/>
              <a:ext cx="6447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ctin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5442018-0BC1-254F-81ED-F26BD5B25FC9}"/>
                </a:ext>
              </a:extLst>
            </p:cNvPr>
            <p:cNvSpPr txBox="1"/>
            <p:nvPr/>
          </p:nvSpPr>
          <p:spPr>
            <a:xfrm>
              <a:off x="1093675" y="6956980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5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9A4E0AE-8CC1-514D-A79C-D73DA8C7D064}"/>
                </a:ext>
              </a:extLst>
            </p:cNvPr>
            <p:cNvSpPr txBox="1"/>
            <p:nvPr/>
          </p:nvSpPr>
          <p:spPr>
            <a:xfrm>
              <a:off x="1093675" y="7235963"/>
              <a:ext cx="3650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37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A0CB9DE-250B-1B43-818F-44327C9C79A2}"/>
                </a:ext>
              </a:extLst>
            </p:cNvPr>
            <p:cNvSpPr txBox="1"/>
            <p:nvPr/>
          </p:nvSpPr>
          <p:spPr>
            <a:xfrm>
              <a:off x="1129743" y="7939319"/>
              <a:ext cx="3650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25</a:t>
              </a:r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2AF9D942-3C48-4684-82F1-D5CF60D23921}"/>
              </a:ext>
            </a:extLst>
          </p:cNvPr>
          <p:cNvGrpSpPr/>
          <p:nvPr/>
        </p:nvGrpSpPr>
        <p:grpSpPr>
          <a:xfrm>
            <a:off x="1047905" y="3981202"/>
            <a:ext cx="2925565" cy="818404"/>
            <a:chOff x="1047905" y="3981202"/>
            <a:chExt cx="2925565" cy="818404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AE955A74-C414-E24C-BC78-B40EEF6E2D9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93856" y="3998575"/>
              <a:ext cx="1888679" cy="732800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CE989C1-CDA6-4C43-BD0F-DE15460CFE1B}"/>
                </a:ext>
              </a:extLst>
            </p:cNvPr>
            <p:cNvSpPr txBox="1"/>
            <p:nvPr/>
          </p:nvSpPr>
          <p:spPr>
            <a:xfrm>
              <a:off x="3310468" y="4180309"/>
              <a:ext cx="6630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ARP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22EB68F-9207-074E-8AD5-DAF2B682CF09}"/>
                </a:ext>
              </a:extLst>
            </p:cNvPr>
            <p:cNvSpPr txBox="1"/>
            <p:nvPr/>
          </p:nvSpPr>
          <p:spPr>
            <a:xfrm>
              <a:off x="1060853" y="3981202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15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F53662B-9972-F14A-8B7C-4993DCE984EC}"/>
                </a:ext>
              </a:extLst>
            </p:cNvPr>
            <p:cNvSpPr txBox="1"/>
            <p:nvPr/>
          </p:nvSpPr>
          <p:spPr>
            <a:xfrm>
              <a:off x="1128922" y="4537996"/>
              <a:ext cx="3650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75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3F220BB-0A4E-9A48-8D24-334610069100}"/>
                </a:ext>
              </a:extLst>
            </p:cNvPr>
            <p:cNvSpPr txBox="1"/>
            <p:nvPr/>
          </p:nvSpPr>
          <p:spPr>
            <a:xfrm>
              <a:off x="1047905" y="4146123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100</a:t>
              </a: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16DE4D05-B283-4AD2-A887-351E8F718C78}"/>
              </a:ext>
            </a:extLst>
          </p:cNvPr>
          <p:cNvGrpSpPr/>
          <p:nvPr/>
        </p:nvGrpSpPr>
        <p:grpSpPr>
          <a:xfrm>
            <a:off x="1128922" y="2844454"/>
            <a:ext cx="4224334" cy="970111"/>
            <a:chOff x="1128922" y="2844454"/>
            <a:chExt cx="4224334" cy="970111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F539E211-8E7E-704E-B133-08F1FDB6A05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400204" y="2953783"/>
              <a:ext cx="1888678" cy="781522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1A3CC9C-6FF2-BC47-A9E4-1D8796D972DB}"/>
                </a:ext>
              </a:extLst>
            </p:cNvPr>
            <p:cNvSpPr txBox="1"/>
            <p:nvPr/>
          </p:nvSpPr>
          <p:spPr>
            <a:xfrm>
              <a:off x="1128922" y="2844454"/>
              <a:ext cx="3650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25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F9BE71A-AD4C-4A4C-AA0B-2A2FA0EACF86}"/>
                </a:ext>
              </a:extLst>
            </p:cNvPr>
            <p:cNvSpPr txBox="1"/>
            <p:nvPr/>
          </p:nvSpPr>
          <p:spPr>
            <a:xfrm>
              <a:off x="1128922" y="3106064"/>
              <a:ext cx="45012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20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20D1CFD0-6A8D-604D-A188-58CD47914D97}"/>
                </a:ext>
              </a:extLst>
            </p:cNvPr>
            <p:cNvSpPr txBox="1"/>
            <p:nvPr/>
          </p:nvSpPr>
          <p:spPr>
            <a:xfrm>
              <a:off x="1140135" y="3510193"/>
              <a:ext cx="3650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15</a:t>
              </a:r>
            </a:p>
          </p:txBody>
        </p: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04D38B22-3847-CD45-8055-71D547755D8A}"/>
                </a:ext>
              </a:extLst>
            </p:cNvPr>
            <p:cNvCxnSpPr/>
            <p:nvPr/>
          </p:nvCxnSpPr>
          <p:spPr>
            <a:xfrm flipH="1">
              <a:off x="3377224" y="3510193"/>
              <a:ext cx="43811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F07474CD-4FFE-4443-8A26-4DDD4150E5E5}"/>
                </a:ext>
              </a:extLst>
            </p:cNvPr>
            <p:cNvSpPr txBox="1"/>
            <p:nvPr/>
          </p:nvSpPr>
          <p:spPr>
            <a:xfrm>
              <a:off x="3815334" y="3168234"/>
              <a:ext cx="153792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leaved Casp3</a:t>
              </a:r>
            </a:p>
            <a:p>
              <a:r>
                <a:rPr lang="en-US" dirty="0"/>
                <a:t>19 and 17 </a:t>
              </a:r>
              <a:r>
                <a:rPr lang="en-US" dirty="0" err="1"/>
                <a:t>kDa</a:t>
              </a:r>
              <a:endParaRPr lang="en-US" dirty="0"/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6665789B-C178-488B-967E-B97551B11461}"/>
              </a:ext>
            </a:extLst>
          </p:cNvPr>
          <p:cNvGrpSpPr/>
          <p:nvPr/>
        </p:nvGrpSpPr>
        <p:grpSpPr>
          <a:xfrm>
            <a:off x="1103044" y="1724192"/>
            <a:ext cx="4455812" cy="942031"/>
            <a:chOff x="1103044" y="1724192"/>
            <a:chExt cx="4455812" cy="942031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FE7111A8-A2EE-444B-A109-89C6FA645E5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399327" y="1724192"/>
              <a:ext cx="1885435" cy="926179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DE1F64E-0B3F-AF4D-BD5E-99BD5A628F91}"/>
                </a:ext>
              </a:extLst>
            </p:cNvPr>
            <p:cNvSpPr txBox="1"/>
            <p:nvPr/>
          </p:nvSpPr>
          <p:spPr>
            <a:xfrm>
              <a:off x="1134393" y="1741592"/>
              <a:ext cx="3650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37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61DEAC4-3252-FB47-902C-38099986C2B3}"/>
                </a:ext>
              </a:extLst>
            </p:cNvPr>
            <p:cNvSpPr txBox="1"/>
            <p:nvPr/>
          </p:nvSpPr>
          <p:spPr>
            <a:xfrm>
              <a:off x="1103044" y="2143003"/>
              <a:ext cx="3650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25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277A2DA-8737-FF4A-BBF5-E4F5D44F8548}"/>
                </a:ext>
              </a:extLst>
            </p:cNvPr>
            <p:cNvSpPr txBox="1"/>
            <p:nvPr/>
          </p:nvSpPr>
          <p:spPr>
            <a:xfrm>
              <a:off x="1103044" y="2404613"/>
              <a:ext cx="45012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20</a:t>
              </a:r>
            </a:p>
          </p:txBody>
        </p: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AA2C3E35-1048-E340-B4CF-77D69D6898A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358681" y="2123108"/>
              <a:ext cx="419175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618572A-0F72-524F-97F6-259227108677}"/>
                </a:ext>
              </a:extLst>
            </p:cNvPr>
            <p:cNvSpPr txBox="1"/>
            <p:nvPr/>
          </p:nvSpPr>
          <p:spPr>
            <a:xfrm>
              <a:off x="3777856" y="1913764"/>
              <a:ext cx="178100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Full length Casp3</a:t>
              </a:r>
            </a:p>
            <a:p>
              <a:r>
                <a:rPr lang="en-US" dirty="0"/>
                <a:t>35 </a:t>
              </a:r>
              <a:r>
                <a:rPr lang="en-US" dirty="0" err="1"/>
                <a:t>kDa</a:t>
              </a:r>
              <a:endParaRPr lang="en-US" dirty="0"/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1F3E5F23-1E4B-4A65-A535-1D0BAE7A0FCE}"/>
              </a:ext>
            </a:extLst>
          </p:cNvPr>
          <p:cNvGrpSpPr/>
          <p:nvPr/>
        </p:nvGrpSpPr>
        <p:grpSpPr>
          <a:xfrm>
            <a:off x="1103044" y="4941855"/>
            <a:ext cx="3141903" cy="1875633"/>
            <a:chOff x="1103044" y="4941855"/>
            <a:chExt cx="3141903" cy="1875633"/>
          </a:xfrm>
        </p:grpSpPr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F84AE034-C5FC-AB47-8DFA-D6395861F3F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430322" y="4941855"/>
              <a:ext cx="1832014" cy="1875633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87C629CA-60BA-064C-AECB-3107BD5E372B}"/>
                </a:ext>
              </a:extLst>
            </p:cNvPr>
            <p:cNvSpPr txBox="1"/>
            <p:nvPr/>
          </p:nvSpPr>
          <p:spPr>
            <a:xfrm>
              <a:off x="3223514" y="5097790"/>
              <a:ext cx="1021433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asp7-FL</a:t>
              </a:r>
            </a:p>
            <a:p>
              <a:r>
                <a:rPr lang="en-US" dirty="0"/>
                <a:t>35 </a:t>
              </a:r>
              <a:r>
                <a:rPr lang="en-US" dirty="0" err="1"/>
                <a:t>kDa</a:t>
              </a:r>
              <a:endParaRPr lang="en-US" dirty="0"/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CB17376A-6786-F74A-A316-212DD78C7436}"/>
                </a:ext>
              </a:extLst>
            </p:cNvPr>
            <p:cNvSpPr txBox="1"/>
            <p:nvPr/>
          </p:nvSpPr>
          <p:spPr>
            <a:xfrm>
              <a:off x="1103044" y="4996475"/>
              <a:ext cx="3650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37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CFCAB93-34F2-B94C-BADB-70DEAC83EEB5}"/>
                </a:ext>
              </a:extLst>
            </p:cNvPr>
            <p:cNvSpPr txBox="1"/>
            <p:nvPr/>
          </p:nvSpPr>
          <p:spPr>
            <a:xfrm>
              <a:off x="1104595" y="5552417"/>
              <a:ext cx="3650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25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75EA219-4BE8-DF49-97E0-1497CD61C640}"/>
                </a:ext>
              </a:extLst>
            </p:cNvPr>
            <p:cNvSpPr txBox="1"/>
            <p:nvPr/>
          </p:nvSpPr>
          <p:spPr>
            <a:xfrm>
              <a:off x="1145123" y="5828152"/>
              <a:ext cx="45012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20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D68EE0E9-9DE1-2C44-9A97-FFA775F7B53C}"/>
                </a:ext>
              </a:extLst>
            </p:cNvPr>
            <p:cNvSpPr txBox="1"/>
            <p:nvPr/>
          </p:nvSpPr>
          <p:spPr>
            <a:xfrm>
              <a:off x="1149847" y="6463687"/>
              <a:ext cx="3650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15</a:t>
              </a: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95384C27-4E78-4C9A-8D03-5E495E2EA8D6}"/>
              </a:ext>
            </a:extLst>
          </p:cNvPr>
          <p:cNvSpPr txBox="1"/>
          <p:nvPr/>
        </p:nvSpPr>
        <p:spPr>
          <a:xfrm>
            <a:off x="498022" y="943071"/>
            <a:ext cx="4514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ull images for Fig. 7e.</a:t>
            </a:r>
          </a:p>
        </p:txBody>
      </p:sp>
    </p:spTree>
    <p:extLst>
      <p:ext uri="{BB962C8B-B14F-4D97-AF65-F5344CB8AC3E}">
        <p14:creationId xmlns:p14="http://schemas.microsoft.com/office/powerpoint/2010/main" val="9599109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26</TotalTime>
  <Words>147</Words>
  <Application>Microsoft Office PowerPoint</Application>
  <PresentationFormat>On-screen Show (4:3)</PresentationFormat>
  <Paragraphs>89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ngqin</dc:creator>
  <cp:lastModifiedBy>MDPI</cp:lastModifiedBy>
  <cp:revision>92</cp:revision>
  <dcterms:created xsi:type="dcterms:W3CDTF">2022-02-10T18:04:15Z</dcterms:created>
  <dcterms:modified xsi:type="dcterms:W3CDTF">2022-08-20T01:50:46Z</dcterms:modified>
</cp:coreProperties>
</file>